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953"/>
    <p:restoredTop sz="94637"/>
  </p:normalViewPr>
  <p:slideViewPr>
    <p:cSldViewPr snapToGrid="0" snapToObjects="1">
      <p:cViewPr varScale="1">
        <p:scale>
          <a:sx n="53" d="100"/>
          <a:sy n="53" d="100"/>
        </p:scale>
        <p:origin x="184" y="13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C98AC3-2281-9743-9B69-9CDB07AF39A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FE23970-F997-C041-B0F1-5E291FD7150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660B15-5897-ED4C-BAE9-1AC940EB5D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D7BD2-CCE9-C04F-9295-3606F3EF204F}" type="datetimeFigureOut">
              <a:rPr lang="en-US" smtClean="0"/>
              <a:t>10/6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FC35812-E522-7243-AA94-7FE89950F1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DB600C-753E-B949-B973-73E77E8CDB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90F80-3127-CD4E-99B6-CE4465ED73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64182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A28481-1134-7440-9E73-C00FCC4119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66C777F-1A3B-514E-B13B-A03083E540D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1E5A8BA-0DFC-A543-8C31-322AB3FB81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D7BD2-CCE9-C04F-9295-3606F3EF204F}" type="datetimeFigureOut">
              <a:rPr lang="en-US" smtClean="0"/>
              <a:t>10/6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790316-E1FC-0F42-8906-C04D167599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52DADF-C87B-8F4E-B795-2CD1BB7BF9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90F80-3127-CD4E-99B6-CE4465ED73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23779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C134669-4614-E04B-AC7B-C96E34A6FD0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F1493B5-C333-C643-AD00-2E4A421119E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8CCF21-B446-C241-860D-C2F3775CF4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D7BD2-CCE9-C04F-9295-3606F3EF204F}" type="datetimeFigureOut">
              <a:rPr lang="en-US" smtClean="0"/>
              <a:t>10/6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5F0752-D487-BD43-9AC9-48DEA65A1D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ADA7C3-C37B-9347-9FDB-D206693482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90F80-3127-CD4E-99B6-CE4465ED73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26838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E89048-C327-DD4F-B355-1546556890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5F73491-2AA6-2C41-B9DE-FB63633FEDE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B418B5-5198-E943-8C52-6F1DB93953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D7BD2-CCE9-C04F-9295-3606F3EF204F}" type="datetimeFigureOut">
              <a:rPr lang="en-US" smtClean="0"/>
              <a:t>10/6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F46B30-D246-9D44-B6C5-148F6E6A1D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5C08A5-5479-134D-B9C7-FC78BD7486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90F80-3127-CD4E-99B6-CE4465ED73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2307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6E6736-F8B2-8843-8CE5-2C2EDB3645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785B263-3ACB-3F49-92B7-2BCCF0ECE9E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95591A-099F-6B4B-ACB9-7F39331E5C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D7BD2-CCE9-C04F-9295-3606F3EF204F}" type="datetimeFigureOut">
              <a:rPr lang="en-US" smtClean="0"/>
              <a:t>10/6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349D4F-BF9D-7A40-A6F0-F91EF210A2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0163016-7B9E-714E-8A81-A196F61835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90F80-3127-CD4E-99B6-CE4465ED73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39423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60DC66-7BF4-0748-A739-849A5823C5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F68B0F6-B82D-5F49-A7CF-51348BA98CD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0B21A8C-8129-A44F-9744-47303EEE34B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1F9ADE3-1261-1441-9F51-27E6B2D8AE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D7BD2-CCE9-C04F-9295-3606F3EF204F}" type="datetimeFigureOut">
              <a:rPr lang="en-US" smtClean="0"/>
              <a:t>10/6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8516574-01A0-224F-A511-0CC472B047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4C57622-656B-744B-95E0-3B8F28E23D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90F80-3127-CD4E-99B6-CE4465ED73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3907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931B6F-A978-CE46-869A-A229BA26BD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ECDC9AB-F3DC-B644-830B-AEAF301022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45F11FA-1EA7-1248-90BD-FF5B72056EE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B5F4F25-2011-4A4F-9376-59C2CFCFDE0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3E734C7-F327-5349-AF57-095362069DD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772B7D3-BCBC-6F41-AECD-CB8F223F55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D7BD2-CCE9-C04F-9295-3606F3EF204F}" type="datetimeFigureOut">
              <a:rPr lang="en-US" smtClean="0"/>
              <a:t>10/6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5E584CE-EAC7-5C40-A727-B1B68DDD64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4B10B4C-E1E6-0147-A01C-E5486B1DC3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90F80-3127-CD4E-99B6-CE4465ED73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23631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3D5AA0-EAB1-8F48-BCF8-BBC2087B40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773C422-439B-6440-9629-AD895000C2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D7BD2-CCE9-C04F-9295-3606F3EF204F}" type="datetimeFigureOut">
              <a:rPr lang="en-US" smtClean="0"/>
              <a:t>10/6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D40F4AA-5EB1-F14D-809D-738077E98A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2D46968-AB53-7E4C-9D30-2DCAD2DBA3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90F80-3127-CD4E-99B6-CE4465ED73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66327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BE25157-0F74-EE42-82B1-E8EAD897D9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D7BD2-CCE9-C04F-9295-3606F3EF204F}" type="datetimeFigureOut">
              <a:rPr lang="en-US" smtClean="0"/>
              <a:t>10/6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5F198EF-0710-3748-AD63-2719114504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4C40C9A-E25E-4C4B-8286-BD71A76E22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90F80-3127-CD4E-99B6-CE4465ED73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24814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F77D30-EAD5-9941-9856-4E7C2AB4A6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1F23C83-FDAC-1E45-AA4C-60DCFD126ED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5CD00E5-816C-804A-AF2E-2315AAAD2E8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5050761-E065-FA46-B35E-D75AB8FF69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D7BD2-CCE9-C04F-9295-3606F3EF204F}" type="datetimeFigureOut">
              <a:rPr lang="en-US" smtClean="0"/>
              <a:t>10/6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724DD24-9E76-CB4C-BBEF-49BB0A14ED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EC9D214-6DAD-7A46-8421-DB708B5070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90F80-3127-CD4E-99B6-CE4465ED73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27690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9482A0-CF67-A442-B92F-97A0FB14A2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F793791-EB10-CD48-907D-1A3E660BFFC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6BD21D6-ABAD-1A4F-85AC-15EB1214604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E1A0094-7BC7-7B45-92AA-8F7940A46A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D7BD2-CCE9-C04F-9295-3606F3EF204F}" type="datetimeFigureOut">
              <a:rPr lang="en-US" smtClean="0"/>
              <a:t>10/6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E1F4D8C-3BDC-8945-815A-6F8BA25BBA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93B94CF-EB9D-4642-9A8A-8BD7273A17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90F80-3127-CD4E-99B6-CE4465ED73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1949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65E1092-0207-824B-B043-7504BAAE7C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768D305-2D73-8541-85D3-40E25A86F7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59D7D83-B2E8-6246-B9F8-F1CD4C11099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6D7BD2-CCE9-C04F-9295-3606F3EF204F}" type="datetimeFigureOut">
              <a:rPr lang="en-US" smtClean="0"/>
              <a:t>10/6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A024BF-7208-194E-B14F-328EE0996C1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23E3FA-D99E-1F40-B405-58A37E821CC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290F80-3127-CD4E-99B6-CE4465ED73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62763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7C6C0F-9115-4A4E-BA9C-29B5A2D9A829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Stimulus Inventory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A58F201-7F3A-D247-94B3-D56049D6934B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02612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EDD107-17D5-EA4C-8A11-42BCD59193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Brain Natriuretic Peptid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9F6B080-2B99-2941-8D5A-F2E68B9ECBB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b="1" dirty="0"/>
              <a:t>152 </a:t>
            </a:r>
            <a:r>
              <a:rPr lang="en-US" b="1" dirty="0" err="1"/>
              <a:t>pg</a:t>
            </a:r>
            <a:r>
              <a:rPr lang="en-US" b="1" dirty="0"/>
              <a:t>/ml</a:t>
            </a:r>
            <a:endParaRPr lang="en-US" dirty="0"/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6147107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56D2BF-6533-3F4C-811F-1ACFB04365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regnancy Test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49C35A0-D93A-A54E-9074-FAE01CF1338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b="1" dirty="0"/>
              <a:t>Negative</a:t>
            </a:r>
          </a:p>
        </p:txBody>
      </p:sp>
    </p:spTree>
    <p:extLst>
      <p:ext uri="{BB962C8B-B14F-4D97-AF65-F5344CB8AC3E}">
        <p14:creationId xmlns:p14="http://schemas.microsoft.com/office/powerpoint/2010/main" val="39322500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A206A5-2C12-EC42-8422-629375F72A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inger Stick Glucos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AE72F01-6EFE-9F45-9CEB-047F6058249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b="1" dirty="0"/>
              <a:t>Blood Glucose Level 	140 mg/dl</a:t>
            </a:r>
            <a:endParaRPr lang="en-US" dirty="0"/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2090479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8D62D8-1116-044A-8ED5-6BB889FA00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rterial Blood Ga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FCF4A2C-3C89-CF42-9C1C-B2F1F402FA7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 fontAlgn="base">
              <a:buNone/>
            </a:pPr>
            <a:r>
              <a:rPr lang="en-US" b="1" dirty="0"/>
              <a:t>Arterial Ph</a:t>
            </a:r>
            <a:r>
              <a:rPr lang="en-US" dirty="0"/>
              <a:t>			</a:t>
            </a:r>
            <a:r>
              <a:rPr lang="en-US" b="1" dirty="0"/>
              <a:t>7.19</a:t>
            </a:r>
            <a:endParaRPr lang="en-US" dirty="0"/>
          </a:p>
          <a:p>
            <a:pPr marL="0" indent="0" fontAlgn="base">
              <a:buNone/>
            </a:pPr>
            <a:r>
              <a:rPr lang="en-US" b="1" dirty="0"/>
              <a:t>pCO2 Arterial</a:t>
            </a:r>
            <a:r>
              <a:rPr lang="en-US" dirty="0"/>
              <a:t>		</a:t>
            </a:r>
            <a:r>
              <a:rPr lang="en-US" b="1" dirty="0"/>
              <a:t>66 mmHg</a:t>
            </a:r>
            <a:endParaRPr lang="en-US" dirty="0"/>
          </a:p>
          <a:p>
            <a:pPr marL="0" indent="0" fontAlgn="base">
              <a:buNone/>
            </a:pPr>
            <a:r>
              <a:rPr lang="en-US" b="1" dirty="0"/>
              <a:t>pO2 Arterial</a:t>
            </a:r>
            <a:r>
              <a:rPr lang="en-US" dirty="0"/>
              <a:t>			</a:t>
            </a:r>
            <a:r>
              <a:rPr lang="en-US" b="1" dirty="0"/>
              <a:t>63 mmHg</a:t>
            </a:r>
            <a:endParaRPr lang="en-US" dirty="0"/>
          </a:p>
          <a:p>
            <a:pPr marL="0" indent="0" fontAlgn="base">
              <a:buNone/>
            </a:pPr>
            <a:r>
              <a:rPr lang="en-US" b="1" dirty="0"/>
              <a:t>HCO3, Arterial Ion</a:t>
            </a:r>
            <a:r>
              <a:rPr lang="en-US" dirty="0"/>
              <a:t>		</a:t>
            </a:r>
            <a:r>
              <a:rPr lang="en-US" b="1" dirty="0"/>
              <a:t>14 </a:t>
            </a:r>
            <a:r>
              <a:rPr lang="en-US" b="1" dirty="0" err="1"/>
              <a:t>mEq</a:t>
            </a:r>
            <a:r>
              <a:rPr lang="en-US" b="1" dirty="0"/>
              <a:t>/L</a:t>
            </a:r>
            <a:endParaRPr lang="en-US" dirty="0"/>
          </a:p>
          <a:p>
            <a:pPr marL="0" indent="0" fontAlgn="base">
              <a:buNone/>
            </a:pPr>
            <a:r>
              <a:rPr lang="en-US" b="1" dirty="0"/>
              <a:t>Arterial O2 Sat </a:t>
            </a:r>
            <a:r>
              <a:rPr lang="en-US" dirty="0"/>
              <a:t>		</a:t>
            </a:r>
            <a:r>
              <a:rPr lang="en-US" b="1" dirty="0"/>
              <a:t>51%</a:t>
            </a:r>
            <a:endParaRPr lang="en-US" dirty="0"/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6866418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55BE07-FC71-6F4D-BCD4-A9B0188E5F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Bedside Ultrasound Showing Right Heart Strain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AF68718-7DAE-1E47-80D8-75C0B883E29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endParaRPr lang="en-US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6BB1C976-B941-B44A-BA17-F2B20A85719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006" t="15384" r="2724" b="28205"/>
          <a:stretch>
            <a:fillRect/>
          </a:stretch>
        </p:blipFill>
        <p:spPr>
          <a:xfrm>
            <a:off x="551293" y="2150729"/>
            <a:ext cx="5367525" cy="393654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A6046A55-5BBB-BA44-9B75-75DDD9ADC59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2150729"/>
            <a:ext cx="5434982" cy="39521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6102217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32AD16-F9CF-9942-B7B6-707774FAB8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hest Radiograph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334397C-8B49-AA4A-81E4-B19F4777804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endParaRPr lang="en-US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6E253A0C-626C-5042-A68C-8B0EFE9CB65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34916" y="1580674"/>
            <a:ext cx="5943600" cy="48412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5651052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9C2A88-B73A-FC43-9E19-32A5203F1F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Electrocardiogram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27D796F-788B-EF46-BB32-E328D89A7E8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endParaRPr lang="en-US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2F69E138-6A64-624D-95E0-7940E33A8B8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19158" y="2070668"/>
            <a:ext cx="8953683" cy="3487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4169176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F21C0E-D50D-874F-BED1-8BF190BBBB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Basic Metabolic Panel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ECB1529-5642-8446-87D6-0BAE8F34A3D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825625"/>
            <a:ext cx="10515600" cy="4667250"/>
          </a:xfrm>
        </p:spPr>
        <p:txBody>
          <a:bodyPr>
            <a:noAutofit/>
          </a:bodyPr>
          <a:lstStyle/>
          <a:p>
            <a:pPr marL="0" indent="0" fontAlgn="base">
              <a:buNone/>
            </a:pPr>
            <a:r>
              <a:rPr lang="en-US" b="1" dirty="0"/>
              <a:t>Sodium</a:t>
            </a:r>
            <a:r>
              <a:rPr lang="en-US" dirty="0"/>
              <a:t>		</a:t>
            </a:r>
            <a:r>
              <a:rPr lang="en-US" b="1" dirty="0"/>
              <a:t>137 </a:t>
            </a:r>
            <a:r>
              <a:rPr lang="en-US" b="1" dirty="0" err="1"/>
              <a:t>mEq</a:t>
            </a:r>
            <a:r>
              <a:rPr lang="en-US" b="1" dirty="0"/>
              <a:t>/L</a:t>
            </a:r>
            <a:endParaRPr lang="en-US" dirty="0"/>
          </a:p>
          <a:p>
            <a:pPr marL="0" indent="0" fontAlgn="base">
              <a:buNone/>
            </a:pPr>
            <a:r>
              <a:rPr lang="pt-BR" b="1" dirty="0" err="1"/>
              <a:t>Potassium</a:t>
            </a:r>
            <a:r>
              <a:rPr lang="pt-BR" dirty="0"/>
              <a:t>		</a:t>
            </a:r>
            <a:r>
              <a:rPr lang="pt-BR" b="1" dirty="0"/>
              <a:t>3.3 </a:t>
            </a:r>
            <a:r>
              <a:rPr lang="pt-BR" b="1" dirty="0" err="1"/>
              <a:t>mEq</a:t>
            </a:r>
            <a:r>
              <a:rPr lang="pt-BR" b="1" dirty="0"/>
              <a:t>/L</a:t>
            </a:r>
            <a:endParaRPr lang="en-US" dirty="0"/>
          </a:p>
          <a:p>
            <a:pPr marL="0" indent="0" fontAlgn="base">
              <a:buNone/>
            </a:pPr>
            <a:r>
              <a:rPr lang="pt-BR" b="1" dirty="0" err="1"/>
              <a:t>Chloride</a:t>
            </a:r>
            <a:r>
              <a:rPr lang="pt-BR" dirty="0"/>
              <a:t>		</a:t>
            </a:r>
            <a:r>
              <a:rPr lang="pt-BR" b="1" dirty="0"/>
              <a:t>106 </a:t>
            </a:r>
            <a:r>
              <a:rPr lang="pt-BR" b="1" dirty="0" err="1"/>
              <a:t>mEq</a:t>
            </a:r>
            <a:r>
              <a:rPr lang="pt-BR" b="1" dirty="0"/>
              <a:t>/L</a:t>
            </a:r>
            <a:endParaRPr lang="en-US" dirty="0"/>
          </a:p>
          <a:p>
            <a:pPr marL="0" indent="0" fontAlgn="base">
              <a:buNone/>
            </a:pPr>
            <a:r>
              <a:rPr lang="pl-PL" b="1" dirty="0"/>
              <a:t>CO2</a:t>
            </a:r>
            <a:r>
              <a:rPr lang="pl-PL" dirty="0"/>
              <a:t>			</a:t>
            </a:r>
            <a:r>
              <a:rPr lang="pl-PL" b="1" dirty="0"/>
              <a:t>18 </a:t>
            </a:r>
            <a:r>
              <a:rPr lang="pl-PL" b="1" dirty="0" err="1"/>
              <a:t>mEq</a:t>
            </a:r>
            <a:r>
              <a:rPr lang="pl-PL" b="1" dirty="0"/>
              <a:t>/L</a:t>
            </a:r>
            <a:endParaRPr lang="en-US" dirty="0"/>
          </a:p>
          <a:p>
            <a:pPr marL="0" indent="0" fontAlgn="base">
              <a:buNone/>
            </a:pPr>
            <a:r>
              <a:rPr lang="pl-PL" b="1" dirty="0"/>
              <a:t>BUN</a:t>
            </a:r>
            <a:r>
              <a:rPr lang="pl-PL" dirty="0"/>
              <a:t>			</a:t>
            </a:r>
            <a:r>
              <a:rPr lang="pl-PL" b="1" dirty="0"/>
              <a:t>9 mg/dl</a:t>
            </a:r>
            <a:endParaRPr lang="en-US" dirty="0"/>
          </a:p>
          <a:p>
            <a:pPr marL="0" indent="0" fontAlgn="base">
              <a:buNone/>
            </a:pPr>
            <a:r>
              <a:rPr lang="it-IT" b="1" dirty="0"/>
              <a:t>Creatinine</a:t>
            </a:r>
            <a:r>
              <a:rPr lang="it-IT" dirty="0"/>
              <a:t>		</a:t>
            </a:r>
            <a:r>
              <a:rPr lang="it-IT" b="1" dirty="0"/>
              <a:t>1.03 mg/dl</a:t>
            </a:r>
            <a:endParaRPr lang="en-US" dirty="0"/>
          </a:p>
          <a:p>
            <a:pPr marL="0" indent="0" fontAlgn="base">
              <a:buNone/>
            </a:pPr>
            <a:r>
              <a:rPr lang="it-IT" b="1" dirty="0" err="1"/>
              <a:t>Glucose</a:t>
            </a:r>
            <a:r>
              <a:rPr lang="it-IT" dirty="0"/>
              <a:t>		</a:t>
            </a:r>
            <a:r>
              <a:rPr lang="it-IT" b="1" dirty="0"/>
              <a:t>155 mg/dl</a:t>
            </a:r>
            <a:endParaRPr lang="en-US" dirty="0"/>
          </a:p>
          <a:p>
            <a:pPr marL="0" indent="0" fontAlgn="base">
              <a:buNone/>
            </a:pPr>
            <a:r>
              <a:rPr lang="en-US" b="1" dirty="0"/>
              <a:t>Calcium</a:t>
            </a:r>
            <a:r>
              <a:rPr lang="en-US" dirty="0"/>
              <a:t>		</a:t>
            </a:r>
            <a:r>
              <a:rPr lang="en-US" b="1" dirty="0"/>
              <a:t>8.8 mg/dl</a:t>
            </a:r>
            <a:endParaRPr lang="en-US" dirty="0"/>
          </a:p>
          <a:p>
            <a:pPr marL="0" indent="0" fontAlgn="base">
              <a:buNone/>
            </a:pPr>
            <a:r>
              <a:rPr lang="en-US" b="1" dirty="0"/>
              <a:t>Anion Gap</a:t>
            </a:r>
            <a:r>
              <a:rPr lang="en-US" dirty="0"/>
              <a:t>		</a:t>
            </a:r>
            <a:r>
              <a:rPr lang="en-US" b="1" dirty="0"/>
              <a:t>13.0 </a:t>
            </a:r>
            <a:endParaRPr lang="en-US" dirty="0"/>
          </a:p>
          <a:p>
            <a:pPr fontAlgn="base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1514397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6B50FD-C2F8-CF48-97A0-433B33CCEA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omplete Blood Count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6A08D03-20AE-9A4E-86F5-2D6065674B7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 fontAlgn="base">
              <a:buNone/>
            </a:pPr>
            <a:r>
              <a:rPr lang="en-US" b="1" dirty="0"/>
              <a:t>WBC Count</a:t>
            </a:r>
            <a:r>
              <a:rPr lang="en-US" dirty="0"/>
              <a:t>		</a:t>
            </a:r>
            <a:r>
              <a:rPr lang="en-US" b="1" dirty="0"/>
              <a:t>25.0 K/µL</a:t>
            </a:r>
            <a:endParaRPr lang="en-US" dirty="0"/>
          </a:p>
          <a:p>
            <a:pPr marL="0" indent="0" fontAlgn="base">
              <a:buNone/>
            </a:pPr>
            <a:r>
              <a:rPr lang="en-US" b="1" dirty="0"/>
              <a:t>RBC Count</a:t>
            </a:r>
            <a:r>
              <a:rPr lang="en-US" dirty="0"/>
              <a:t>		</a:t>
            </a:r>
            <a:r>
              <a:rPr lang="en-US" b="1" dirty="0"/>
              <a:t>4.60 M/µL</a:t>
            </a:r>
            <a:endParaRPr lang="en-US" dirty="0"/>
          </a:p>
          <a:p>
            <a:pPr marL="0" indent="0" fontAlgn="base">
              <a:buNone/>
            </a:pPr>
            <a:r>
              <a:rPr lang="en-US" b="1" dirty="0"/>
              <a:t>Hemoglobin</a:t>
            </a:r>
            <a:r>
              <a:rPr lang="en-US" dirty="0"/>
              <a:t>		</a:t>
            </a:r>
            <a:r>
              <a:rPr lang="en-US" b="1" dirty="0"/>
              <a:t>12.4 g/dL</a:t>
            </a:r>
            <a:endParaRPr lang="en-US" dirty="0"/>
          </a:p>
          <a:p>
            <a:pPr marL="0" indent="0" fontAlgn="base">
              <a:buNone/>
            </a:pPr>
            <a:r>
              <a:rPr lang="en-US" b="1" dirty="0"/>
              <a:t>Hematocrit</a:t>
            </a:r>
            <a:r>
              <a:rPr lang="en-US" dirty="0"/>
              <a:t>		</a:t>
            </a:r>
            <a:r>
              <a:rPr lang="en-US" b="1" dirty="0"/>
              <a:t>38.8%</a:t>
            </a:r>
            <a:endParaRPr lang="en-US" dirty="0"/>
          </a:p>
          <a:p>
            <a:pPr marL="0" indent="0" fontAlgn="base">
              <a:buNone/>
            </a:pPr>
            <a:r>
              <a:rPr lang="en-US" b="1" dirty="0"/>
              <a:t>Platelets</a:t>
            </a:r>
            <a:r>
              <a:rPr lang="en-US" dirty="0"/>
              <a:t>		</a:t>
            </a:r>
            <a:r>
              <a:rPr lang="en-US" b="1" dirty="0"/>
              <a:t>373 K/µL</a:t>
            </a:r>
            <a:endParaRPr lang="en-US" dirty="0"/>
          </a:p>
          <a:p>
            <a:pPr marL="0" indent="0" fontAlgn="base">
              <a:buNone/>
            </a:pPr>
            <a:r>
              <a:rPr lang="en-US" b="1" dirty="0"/>
              <a:t>Neutrophils %</a:t>
            </a:r>
            <a:r>
              <a:rPr lang="en-US" dirty="0"/>
              <a:t>	</a:t>
            </a:r>
            <a:r>
              <a:rPr lang="en-US" b="1" dirty="0"/>
              <a:t>39.0%  </a:t>
            </a:r>
            <a:endParaRPr lang="en-US" dirty="0"/>
          </a:p>
          <a:p>
            <a:pPr marL="0" indent="0" fontAlgn="base">
              <a:buNone/>
            </a:pPr>
            <a:r>
              <a:rPr lang="en-US" b="1" dirty="0"/>
              <a:t>Lymphocytes %</a:t>
            </a:r>
            <a:r>
              <a:rPr lang="en-US" dirty="0"/>
              <a:t>	</a:t>
            </a:r>
            <a:r>
              <a:rPr lang="en-US" b="1" dirty="0"/>
              <a:t>54.0%</a:t>
            </a:r>
            <a:endParaRPr lang="en-US" dirty="0"/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3429160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1EC404-85F3-974A-8395-9C9DA7A66D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roponin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EF681A6-88F8-2A4B-A339-F02E0CBC39E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b="1" dirty="0"/>
              <a:t>0.64 ng/ml</a:t>
            </a:r>
            <a:endParaRPr lang="en-US" dirty="0"/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656322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190</Words>
  <Application>Microsoft Macintosh PowerPoint</Application>
  <PresentationFormat>Widescreen</PresentationFormat>
  <Paragraphs>36</Paragraphs>
  <Slides>1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5" baseType="lpstr">
      <vt:lpstr>Arial</vt:lpstr>
      <vt:lpstr>Calibri</vt:lpstr>
      <vt:lpstr>Calibri Light</vt:lpstr>
      <vt:lpstr>Office Theme</vt:lpstr>
      <vt:lpstr>Stimulus Inventory</vt:lpstr>
      <vt:lpstr>Finger Stick Glucose</vt:lpstr>
      <vt:lpstr>Arterial Blood Gas</vt:lpstr>
      <vt:lpstr>Bedside Ultrasound Showing Right Heart Strain</vt:lpstr>
      <vt:lpstr>Chest Radiograph</vt:lpstr>
      <vt:lpstr>Electrocardiogram</vt:lpstr>
      <vt:lpstr>Basic Metabolic Panel</vt:lpstr>
      <vt:lpstr>Complete Blood Count</vt:lpstr>
      <vt:lpstr>Troponin</vt:lpstr>
      <vt:lpstr>Brain Natriuretic Peptide</vt:lpstr>
      <vt:lpstr>Pregnancy Tes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timulus Inventory</dc:title>
  <dc:creator>Cheyenne Low</dc:creator>
  <cp:lastModifiedBy>Cheyenne Low</cp:lastModifiedBy>
  <cp:revision>15</cp:revision>
  <dcterms:created xsi:type="dcterms:W3CDTF">2021-10-07T03:47:09Z</dcterms:created>
  <dcterms:modified xsi:type="dcterms:W3CDTF">2021-10-07T04:00:08Z</dcterms:modified>
</cp:coreProperties>
</file>